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  <p:sldId id="257" r:id="rId4"/>
    <p:sldId id="259" r:id="rId5"/>
    <p:sldId id="260" r:id="rId6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844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5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28600" y="304800"/>
            <a:ext cx="6417398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b="1" dirty="0" smtClean="0"/>
              <a:t>Supplementary Presentation 1</a:t>
            </a:r>
            <a:r>
              <a:rPr lang="en-IN" dirty="0" smtClean="0"/>
              <a:t>. </a:t>
            </a:r>
            <a:r>
              <a:rPr lang="en-IN" dirty="0" err="1" smtClean="0"/>
              <a:t>Barplots</a:t>
            </a:r>
            <a:r>
              <a:rPr lang="en-IN" dirty="0" smtClean="0"/>
              <a:t> of the average normalized</a:t>
            </a:r>
          </a:p>
          <a:p>
            <a:r>
              <a:rPr lang="en-IN" dirty="0" smtClean="0"/>
              <a:t> relative abundance of the 25 most abundant bacterial </a:t>
            </a:r>
            <a:r>
              <a:rPr lang="en-IN" dirty="0" err="1" smtClean="0"/>
              <a:t>taxa</a:t>
            </a:r>
            <a:r>
              <a:rPr lang="en-IN" dirty="0" smtClean="0"/>
              <a:t> at</a:t>
            </a:r>
          </a:p>
          <a:p>
            <a:r>
              <a:rPr lang="en-IN" dirty="0" smtClean="0"/>
              <a:t> different taxonomic levels, found in different groups.</a:t>
            </a:r>
          </a:p>
          <a:p>
            <a:r>
              <a:rPr lang="en-IN" dirty="0" smtClean="0"/>
              <a:t> ‘Others” are </a:t>
            </a:r>
            <a:r>
              <a:rPr lang="en-IN" dirty="0" err="1" smtClean="0"/>
              <a:t>taxa</a:t>
            </a:r>
            <a:r>
              <a:rPr lang="en-IN" dirty="0" smtClean="0"/>
              <a:t> not included in the 25 most abundant </a:t>
            </a:r>
            <a:r>
              <a:rPr lang="en-IN" dirty="0" err="1" smtClean="0"/>
              <a:t>taxa</a:t>
            </a:r>
            <a:r>
              <a:rPr lang="en-IN" dirty="0" smtClean="0"/>
              <a:t>.</a:t>
            </a:r>
            <a:endParaRPr lang="en-IN" dirty="0"/>
          </a:p>
        </p:txBody>
      </p:sp>
      <p:pic>
        <p:nvPicPr>
          <p:cNvPr id="3" name="Picture 2" descr="C:\H\DBT_DAPRI_AMR\agrigenome_fIRST TRIAL\AGRIGENOME AMPLISEQ FIRST TRIAL\NGS_P6238tr1amplisq\NGS_P6238_SupplementaryFiles\metageneassist\metageneassist_stripotu_Nofilter_pareto\barh.genus.Treatment.Control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33400" y="2286000"/>
            <a:ext cx="5276850" cy="302895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C:\H\DBT_DAPRI_AMR\agrigenome_fIRST TRIAL\AGRIGENOME AMPLISEQ FIRST TRIAL\NGS_P6238tr1amplisq\NGS_P6238_SupplementaryFiles\metageneassist\metageneassist_stripotu_Nofilter_pareto\barh.genus.Treatment.VIR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04800" y="1371600"/>
            <a:ext cx="5553075" cy="3019425"/>
          </a:xfrm>
          <a:prstGeom prst="rect">
            <a:avLst/>
          </a:prstGeom>
          <a:noFill/>
        </p:spPr>
      </p:pic>
      <p:pic>
        <p:nvPicPr>
          <p:cNvPr id="1028" name="Picture 4" descr="C:\H\DBT_DAPRI_AMR\agrigenome_fIRST TRIAL\AGRIGENOME AMPLISEQ FIRST TRIAL\NGS_P6238tr1amplisq\NGS_P6238_SupplementaryFiles\metageneassist\metageneassist_stripotu_Nofilter_pareto\barh.genus.Treatment.LIN.pn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0" y="4800600"/>
            <a:ext cx="5734050" cy="3019425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H\DBT_DAPRI_AMR\agrigenome_fIRST TRIAL\AGRIGENOME AMPLISEQ FIRST TRIAL\NGS_P6238tr1amplisq\NGS_P6238_SupplementaryFiles\metageneassist\metageneassist_stripotu_Nofilter_pareto\barh.genus.Treatment.BMD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04800" y="0"/>
            <a:ext cx="5734050" cy="3019425"/>
          </a:xfrm>
          <a:prstGeom prst="rect">
            <a:avLst/>
          </a:prstGeom>
          <a:noFill/>
        </p:spPr>
      </p:pic>
      <p:pic>
        <p:nvPicPr>
          <p:cNvPr id="2051" name="Picture 3" descr="C:\H\DBT_DAPRI_AMR\agrigenome_fIRST TRIAL\AGRIGENOME AMPLISEQ FIRST TRIAL\NGS_P6238tr1amplisq\NGS_P6238_SupplementaryFiles\metageneassist\metageneassist_stripotu_Nofilter_pareto\barh.genus.Treatment.CTC.pn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838200" y="3048000"/>
            <a:ext cx="5276850" cy="3019425"/>
          </a:xfrm>
          <a:prstGeom prst="rect">
            <a:avLst/>
          </a:prstGeom>
          <a:noFill/>
        </p:spPr>
      </p:pic>
      <p:pic>
        <p:nvPicPr>
          <p:cNvPr id="2052" name="Picture 4" descr="C:\H\DBT_DAPRI_AMR\agrigenome_fIRST TRIAL\AGRIGENOME AMPLISEQ FIRST TRIAL\NGS_P6238tr1amplisq\NGS_P6238_SupplementaryFiles\metageneassist\metageneassist_stripotu_Nofilter_pareto\barh.genus.Treatment.TYL.pn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09600" y="6124575"/>
            <a:ext cx="5476875" cy="3019425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barh.taxa.all.Treatment.CON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304800"/>
            <a:ext cx="6858000" cy="2961834"/>
          </a:xfrm>
          <a:prstGeom prst="rect">
            <a:avLst/>
          </a:prstGeom>
        </p:spPr>
      </p:pic>
      <p:pic>
        <p:nvPicPr>
          <p:cNvPr id="3" name="Picture 2" descr="barh.taxa.all.Treatment.VIR.pn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0" y="3200400"/>
            <a:ext cx="6858000" cy="2986244"/>
          </a:xfrm>
          <a:prstGeom prst="rect">
            <a:avLst/>
          </a:prstGeom>
        </p:spPr>
      </p:pic>
      <p:pic>
        <p:nvPicPr>
          <p:cNvPr id="4" name="Picture 3" descr="barh.taxa.all.Treatment.LIN.png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0" y="6157756"/>
            <a:ext cx="6858000" cy="2986244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barh.taxa.all.Treatment.BMD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228600"/>
            <a:ext cx="6858000" cy="2990352"/>
          </a:xfrm>
          <a:prstGeom prst="rect">
            <a:avLst/>
          </a:prstGeom>
        </p:spPr>
      </p:pic>
      <p:pic>
        <p:nvPicPr>
          <p:cNvPr id="3" name="Picture 2" descr="barh.taxa.all.Treatment.CTC.pn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0" y="3200400"/>
            <a:ext cx="6858000" cy="2986244"/>
          </a:xfrm>
          <a:prstGeom prst="rect">
            <a:avLst/>
          </a:prstGeom>
        </p:spPr>
      </p:pic>
      <p:pic>
        <p:nvPicPr>
          <p:cNvPr id="4" name="Picture 3" descr="barh.taxa.all.Treatment.TYL.png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0" y="6157756"/>
            <a:ext cx="6858000" cy="2986244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</TotalTime>
  <Words>45</Words>
  <Application>Microsoft Office PowerPoint</Application>
  <PresentationFormat>On-screen Show (4:3)</PresentationFormat>
  <Paragraphs>4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Slide 1</vt:lpstr>
      <vt:lpstr>Slide 2</vt:lpstr>
      <vt:lpstr>Slide 3</vt:lpstr>
      <vt:lpstr>Slide 4</vt:lpstr>
      <vt:lpstr>Slide 5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hyam</dc:creator>
  <cp:lastModifiedBy>Shyam</cp:lastModifiedBy>
  <cp:revision>9</cp:revision>
  <dcterms:created xsi:type="dcterms:W3CDTF">2006-08-16T00:00:00Z</dcterms:created>
  <dcterms:modified xsi:type="dcterms:W3CDTF">2022-05-20T07:41:29Z</dcterms:modified>
</cp:coreProperties>
</file>